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130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6237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2873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454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5517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2102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4191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5877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0631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99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712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576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0818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 descr="图表, 箱线图&#10;&#10;描述已自动生成">
            <a:extLst>
              <a:ext uri="{FF2B5EF4-FFF2-40B4-BE49-F238E27FC236}">
                <a16:creationId xmlns:a16="http://schemas.microsoft.com/office/drawing/2014/main" id="{559B373D-C8CC-EE20-46EF-621C5749862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223" y="148072"/>
            <a:ext cx="7684635" cy="5686976"/>
          </a:xfr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8DE1177-A61A-7AD0-39DC-A974AD2592FC}"/>
              </a:ext>
            </a:extLst>
          </p:cNvPr>
          <p:cNvSpPr txBox="1"/>
          <p:nvPr/>
        </p:nvSpPr>
        <p:spPr>
          <a:xfrm>
            <a:off x="542223" y="5817311"/>
            <a:ext cx="8361145" cy="8926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4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1.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orest plot of the prognostic effect of relevant variables on OS. </a:t>
            </a: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R are calculated using Cox proportional hazards regression models and presented with 95% CIs. </a:t>
            </a:r>
            <a:endParaRPr lang="zh-CN" altLang="zh-CN" sz="14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0370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</TotalTime>
  <Words>32</Words>
  <Application>Microsoft Office PowerPoint</Application>
  <PresentationFormat>全屏显示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ng Dai</dc:creator>
  <cp:lastModifiedBy>Ying Dai</cp:lastModifiedBy>
  <cp:revision>1</cp:revision>
  <dcterms:created xsi:type="dcterms:W3CDTF">2023-12-11T13:09:18Z</dcterms:created>
  <dcterms:modified xsi:type="dcterms:W3CDTF">2023-12-11T13:16:00Z</dcterms:modified>
</cp:coreProperties>
</file>